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01" r:id="rId2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99FF"/>
    <a:srgbClr val="0000FF"/>
    <a:srgbClr val="FF33CC"/>
    <a:srgbClr val="FFC000"/>
    <a:srgbClr val="FFCC99"/>
    <a:srgbClr val="00CCFF"/>
    <a:srgbClr val="6699FF"/>
    <a:srgbClr val="6666FF"/>
    <a:srgbClr val="99CCFF"/>
    <a:srgbClr val="CC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629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45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C:\Users\CASE\Desktop\02-Nov-2022.xls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../embeddings/oleObject1.bin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1324102745427322"/>
          <c:y val="4.8592178417665451E-2"/>
          <c:w val="0.83996745689807628"/>
          <c:h val="0.636661077507464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FF0000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ysClr val="windowText" lastClr="000000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6E75-4997-A8BD-A9D026CE56FD}"/>
              </c:ext>
            </c:extLst>
          </c:dPt>
          <c:dPt>
            <c:idx val="2"/>
            <c:invertIfNegative val="0"/>
            <c:bubble3D val="0"/>
            <c:spPr>
              <a:solidFill>
                <a:srgbClr val="00B050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6E75-4997-A8BD-A9D026CE56FD}"/>
              </c:ext>
            </c:extLst>
          </c:dPt>
          <c:dPt>
            <c:idx val="3"/>
            <c:invertIfNegative val="0"/>
            <c:bubble3D val="0"/>
            <c:spPr>
              <a:solidFill>
                <a:srgbClr val="00B050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6E75-4997-A8BD-A9D026CE56FD}"/>
              </c:ext>
            </c:extLst>
          </c:dPt>
          <c:dPt>
            <c:idx val="11"/>
            <c:invertIfNegative val="0"/>
            <c:bubble3D val="0"/>
            <c:spPr>
              <a:solidFill>
                <a:srgbClr val="4472C4">
                  <a:lumMod val="40000"/>
                  <a:lumOff val="60000"/>
                </a:srgb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6E75-4997-A8BD-A9D026CE56FD}"/>
              </c:ext>
            </c:extLst>
          </c:dPt>
          <c:dPt>
            <c:idx val="12"/>
            <c:invertIfNegative val="0"/>
            <c:bubble3D val="0"/>
            <c:spPr>
              <a:solidFill>
                <a:srgbClr val="4472C4">
                  <a:lumMod val="40000"/>
                  <a:lumOff val="60000"/>
                </a:srgb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8-6E75-4997-A8BD-A9D026CE56FD}"/>
              </c:ext>
            </c:extLst>
          </c:dPt>
          <c:dPt>
            <c:idx val="13"/>
            <c:invertIfNegative val="0"/>
            <c:bubble3D val="0"/>
            <c:spPr>
              <a:solidFill>
                <a:srgbClr val="4472C4">
                  <a:lumMod val="40000"/>
                  <a:lumOff val="60000"/>
                </a:srgb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6E75-4997-A8BD-A9D026CE56FD}"/>
              </c:ext>
            </c:extLst>
          </c:dPt>
          <c:dPt>
            <c:idx val="14"/>
            <c:invertIfNegative val="0"/>
            <c:bubble3D val="0"/>
            <c:spPr>
              <a:solidFill>
                <a:srgbClr val="4472C4">
                  <a:lumMod val="40000"/>
                  <a:lumOff val="60000"/>
                </a:srgb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A-6E75-4997-A8BD-A9D026CE56FD}"/>
              </c:ext>
            </c:extLst>
          </c:dPt>
          <c:dPt>
            <c:idx val="15"/>
            <c:invertIfNegative val="0"/>
            <c:bubble3D val="0"/>
            <c:spPr>
              <a:solidFill>
                <a:srgbClr val="4472C4">
                  <a:lumMod val="40000"/>
                  <a:lumOff val="60000"/>
                </a:srgb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6E75-4997-A8BD-A9D026CE56FD}"/>
              </c:ext>
            </c:extLst>
          </c:dPt>
          <c:dPt>
            <c:idx val="17"/>
            <c:invertIfNegative val="0"/>
            <c:bubble3D val="0"/>
            <c:spPr>
              <a:solidFill>
                <a:srgbClr val="FFC000">
                  <a:lumMod val="40000"/>
                  <a:lumOff val="60000"/>
                </a:srgb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6E75-4997-A8BD-A9D026CE56FD}"/>
              </c:ext>
            </c:extLst>
          </c:dPt>
          <c:dPt>
            <c:idx val="18"/>
            <c:invertIfNegative val="0"/>
            <c:bubble3D val="0"/>
            <c:spPr>
              <a:solidFill>
                <a:srgbClr val="FFC000">
                  <a:lumMod val="40000"/>
                  <a:lumOff val="60000"/>
                </a:srgb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C-6E75-4997-A8BD-A9D026CE56FD}"/>
              </c:ext>
            </c:extLst>
          </c:dPt>
          <c:dPt>
            <c:idx val="19"/>
            <c:invertIfNegative val="0"/>
            <c:bubble3D val="0"/>
            <c:spPr>
              <a:solidFill>
                <a:srgbClr val="FFC000">
                  <a:lumMod val="40000"/>
                  <a:lumOff val="60000"/>
                </a:srgb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E-6E75-4997-A8BD-A9D026CE56FD}"/>
              </c:ext>
            </c:extLst>
          </c:dPt>
          <c:dPt>
            <c:idx val="20"/>
            <c:invertIfNegative val="0"/>
            <c:bubble3D val="0"/>
            <c:spPr>
              <a:solidFill>
                <a:srgbClr val="FFC000">
                  <a:lumMod val="40000"/>
                  <a:lumOff val="60000"/>
                </a:srgb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6E75-4997-A8BD-A9D026CE56FD}"/>
              </c:ext>
            </c:extLst>
          </c:dPt>
          <c:dPt>
            <c:idx val="21"/>
            <c:invertIfNegative val="0"/>
            <c:bubble3D val="0"/>
            <c:spPr>
              <a:solidFill>
                <a:srgbClr val="FFC000">
                  <a:lumMod val="40000"/>
                  <a:lumOff val="60000"/>
                </a:srgb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0-6E75-4997-A8BD-A9D026CE56FD}"/>
              </c:ext>
            </c:extLst>
          </c:dPt>
          <c:errBars>
            <c:errBarType val="both"/>
            <c:errValType val="cust"/>
            <c:noEndCap val="0"/>
            <c:plus>
              <c:numRef>
                <c:f>Sheet0!$N$3:$N$27</c:f>
                <c:numCache>
                  <c:formatCode>General</c:formatCode>
                  <c:ptCount val="25"/>
                  <c:pt idx="0">
                    <c:v>3.8334124171992112</c:v>
                  </c:pt>
                  <c:pt idx="2">
                    <c:v>3.6609480533011496</c:v>
                  </c:pt>
                  <c:pt idx="3">
                    <c:v>2.971298771144681</c:v>
                  </c:pt>
                  <c:pt idx="5">
                    <c:v>5.9439913485158531</c:v>
                  </c:pt>
                  <c:pt idx="6">
                    <c:v>4.8908217287028553</c:v>
                  </c:pt>
                  <c:pt idx="7">
                    <c:v>4.6640198471665189</c:v>
                  </c:pt>
                  <c:pt idx="8">
                    <c:v>4.8041539842016601</c:v>
                  </c:pt>
                  <c:pt idx="9">
                    <c:v>5.4486478282642041</c:v>
                  </c:pt>
                  <c:pt idx="11">
                    <c:v>9.282331737846258</c:v>
                  </c:pt>
                  <c:pt idx="12">
                    <c:v>15.71445136221303</c:v>
                  </c:pt>
                  <c:pt idx="13">
                    <c:v>12.479103700318403</c:v>
                  </c:pt>
                  <c:pt idx="14">
                    <c:v>7.8652488864630774</c:v>
                  </c:pt>
                  <c:pt idx="15">
                    <c:v>8.0734752203851112</c:v>
                  </c:pt>
                  <c:pt idx="17">
                    <c:v>6.6554955268005562</c:v>
                  </c:pt>
                  <c:pt idx="18">
                    <c:v>11.779297735205663</c:v>
                  </c:pt>
                  <c:pt idx="19">
                    <c:v>14.792755701093272</c:v>
                  </c:pt>
                  <c:pt idx="20">
                    <c:v>6.6852692067062387</c:v>
                  </c:pt>
                  <c:pt idx="21">
                    <c:v>14.060294844525753</c:v>
                  </c:pt>
                  <c:pt idx="23">
                    <c:v>2.4576534215654378</c:v>
                  </c:pt>
                  <c:pt idx="24">
                    <c:v>9.0825140287366111</c:v>
                  </c:pt>
                </c:numCache>
              </c:numRef>
            </c:plus>
            <c:minus>
              <c:numRef>
                <c:f>Sheet0!$N$3:$N$27</c:f>
                <c:numCache>
                  <c:formatCode>General</c:formatCode>
                  <c:ptCount val="25"/>
                  <c:pt idx="0">
                    <c:v>3.8334124171992112</c:v>
                  </c:pt>
                  <c:pt idx="2">
                    <c:v>3.6609480533011496</c:v>
                  </c:pt>
                  <c:pt idx="3">
                    <c:v>2.971298771144681</c:v>
                  </c:pt>
                  <c:pt idx="5">
                    <c:v>5.9439913485158531</c:v>
                  </c:pt>
                  <c:pt idx="6">
                    <c:v>4.8908217287028553</c:v>
                  </c:pt>
                  <c:pt idx="7">
                    <c:v>4.6640198471665189</c:v>
                  </c:pt>
                  <c:pt idx="8">
                    <c:v>4.8041539842016601</c:v>
                  </c:pt>
                  <c:pt idx="9">
                    <c:v>5.4486478282642041</c:v>
                  </c:pt>
                  <c:pt idx="11">
                    <c:v>9.282331737846258</c:v>
                  </c:pt>
                  <c:pt idx="12">
                    <c:v>15.71445136221303</c:v>
                  </c:pt>
                  <c:pt idx="13">
                    <c:v>12.479103700318403</c:v>
                  </c:pt>
                  <c:pt idx="14">
                    <c:v>7.8652488864630774</c:v>
                  </c:pt>
                  <c:pt idx="15">
                    <c:v>8.0734752203851112</c:v>
                  </c:pt>
                  <c:pt idx="17">
                    <c:v>6.6554955268005562</c:v>
                  </c:pt>
                  <c:pt idx="18">
                    <c:v>11.779297735205663</c:v>
                  </c:pt>
                  <c:pt idx="19">
                    <c:v>14.792755701093272</c:v>
                  </c:pt>
                  <c:pt idx="20">
                    <c:v>6.6852692067062387</c:v>
                  </c:pt>
                  <c:pt idx="21">
                    <c:v>14.060294844525753</c:v>
                  </c:pt>
                  <c:pt idx="23">
                    <c:v>2.4576534215654378</c:v>
                  </c:pt>
                  <c:pt idx="24">
                    <c:v>9.0825140287366111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Sheet0!$G$3:$G$24</c:f>
              <c:strCache>
                <c:ptCount val="22"/>
                <c:pt idx="0">
                  <c:v>Untreated</c:v>
                </c:pt>
                <c:pt idx="2">
                  <c:v>BTZ 5nM</c:v>
                </c:pt>
                <c:pt idx="3">
                  <c:v>B3Z 10nM</c:v>
                </c:pt>
                <c:pt idx="5">
                  <c:v>Tub-A</c:v>
                </c:pt>
                <c:pt idx="6">
                  <c:v>WT161</c:v>
                </c:pt>
                <c:pt idx="7">
                  <c:v>ACY-1215</c:v>
                </c:pt>
                <c:pt idx="8">
                  <c:v>ACY-738</c:v>
                </c:pt>
                <c:pt idx="9">
                  <c:v>ACY-241</c:v>
                </c:pt>
                <c:pt idx="11">
                  <c:v>Tub-A</c:v>
                </c:pt>
                <c:pt idx="12">
                  <c:v>WT161</c:v>
                </c:pt>
                <c:pt idx="13">
                  <c:v>ACY-1215</c:v>
                </c:pt>
                <c:pt idx="14">
                  <c:v>ACY-738</c:v>
                </c:pt>
                <c:pt idx="15">
                  <c:v>ACY-241</c:v>
                </c:pt>
                <c:pt idx="17">
                  <c:v>Tub-A</c:v>
                </c:pt>
                <c:pt idx="18">
                  <c:v>WT161</c:v>
                </c:pt>
                <c:pt idx="19">
                  <c:v>ACY-1215</c:v>
                </c:pt>
                <c:pt idx="20">
                  <c:v>ACY-738</c:v>
                </c:pt>
                <c:pt idx="21">
                  <c:v>ACY-241</c:v>
                </c:pt>
              </c:strCache>
            </c:strRef>
          </c:cat>
          <c:val>
            <c:numRef>
              <c:f>Sheet0!$L$3:$L$24</c:f>
              <c:numCache>
                <c:formatCode>General</c:formatCode>
                <c:ptCount val="22"/>
                <c:pt idx="0">
                  <c:v>100</c:v>
                </c:pt>
                <c:pt idx="2">
                  <c:v>114.21499292786422</c:v>
                </c:pt>
                <c:pt idx="3">
                  <c:v>141.65487977369165</c:v>
                </c:pt>
                <c:pt idx="5">
                  <c:v>75.247524752475243</c:v>
                </c:pt>
                <c:pt idx="6">
                  <c:v>84.582743988684584</c:v>
                </c:pt>
                <c:pt idx="7">
                  <c:v>93.140028288543135</c:v>
                </c:pt>
                <c:pt idx="8">
                  <c:v>74.893917963224894</c:v>
                </c:pt>
                <c:pt idx="9">
                  <c:v>15.912305516265912</c:v>
                </c:pt>
                <c:pt idx="11">
                  <c:v>29.985855728429982</c:v>
                </c:pt>
                <c:pt idx="12">
                  <c:v>21.570014144271571</c:v>
                </c:pt>
                <c:pt idx="13">
                  <c:v>100.07072135785006</c:v>
                </c:pt>
                <c:pt idx="14">
                  <c:v>24.115983026874115</c:v>
                </c:pt>
                <c:pt idx="15">
                  <c:v>59.264497878359265</c:v>
                </c:pt>
                <c:pt idx="17">
                  <c:v>12.446958981612447</c:v>
                </c:pt>
                <c:pt idx="18">
                  <c:v>34.016973125884014</c:v>
                </c:pt>
                <c:pt idx="19">
                  <c:v>44.200848656294198</c:v>
                </c:pt>
                <c:pt idx="20">
                  <c:v>63.295615275813297</c:v>
                </c:pt>
                <c:pt idx="21">
                  <c:v>22.0650636492220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6E75-4997-A8BD-A9D026CE56F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"/>
        <c:axId val="607278200"/>
        <c:axId val="1131435656"/>
      </c:barChart>
      <c:catAx>
        <c:axId val="607278200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3000000" spcFirstLastPara="1" vertOverflow="ellipsis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31435656"/>
        <c:crosses val="autoZero"/>
        <c:auto val="1"/>
        <c:lblAlgn val="ctr"/>
        <c:lblOffset val="100"/>
        <c:tickMarkSkip val="1"/>
        <c:noMultiLvlLbl val="0"/>
      </c:catAx>
      <c:valAx>
        <c:axId val="1131435656"/>
        <c:scaling>
          <c:orientation val="minMax"/>
          <c:max val="15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/>
                  <a:t>Autophagosomes,</a:t>
                </a:r>
                <a:r>
                  <a:rPr lang="en-US" b="1" baseline="0"/>
                  <a:t> Relative %</a:t>
                </a:r>
                <a:endParaRPr lang="en-US" b="1"/>
              </a:p>
            </c:rich>
          </c:tx>
          <c:layout>
            <c:manualLayout>
              <c:xMode val="edge"/>
              <c:yMode val="edge"/>
              <c:x val="2.4942662943670906E-2"/>
              <c:y val="6.8265033211438689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07278200"/>
        <c:crosses val="autoZero"/>
        <c:crossBetween val="between"/>
        <c:majorUnit val="2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0696557233194426"/>
          <c:y val="2.4304584304584306E-2"/>
          <c:w val="0.88214018974764585"/>
          <c:h val="0.7113077041840356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ysClr val="windowText" lastClr="000000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B122-43AB-B0DE-4EF4CAAA176C}"/>
              </c:ext>
            </c:extLst>
          </c:dPt>
          <c:dPt>
            <c:idx val="2"/>
            <c:invertIfNegative val="0"/>
            <c:bubble3D val="0"/>
            <c:spPr>
              <a:solidFill>
                <a:srgbClr val="00B050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B122-43AB-B0DE-4EF4CAAA176C}"/>
              </c:ext>
            </c:extLst>
          </c:dPt>
          <c:dPt>
            <c:idx val="3"/>
            <c:invertIfNegative val="0"/>
            <c:bubble3D val="0"/>
            <c:spPr>
              <a:solidFill>
                <a:srgbClr val="00B050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B122-43AB-B0DE-4EF4CAAA176C}"/>
              </c:ext>
            </c:extLst>
          </c:dPt>
          <c:dPt>
            <c:idx val="5"/>
            <c:invertIfNegative val="0"/>
            <c:bubble3D val="0"/>
            <c:spPr>
              <a:solidFill>
                <a:srgbClr val="FF0000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B122-43AB-B0DE-4EF4CAAA176C}"/>
              </c:ext>
            </c:extLst>
          </c:dPt>
          <c:dPt>
            <c:idx val="6"/>
            <c:invertIfNegative val="0"/>
            <c:bubble3D val="0"/>
            <c:spPr>
              <a:solidFill>
                <a:srgbClr val="FF0000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B122-43AB-B0DE-4EF4CAAA176C}"/>
              </c:ext>
            </c:extLst>
          </c:dPt>
          <c:dPt>
            <c:idx val="7"/>
            <c:invertIfNegative val="0"/>
            <c:bubble3D val="0"/>
            <c:spPr>
              <a:solidFill>
                <a:srgbClr val="FF0000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B122-43AB-B0DE-4EF4CAAA176C}"/>
              </c:ext>
            </c:extLst>
          </c:dPt>
          <c:dPt>
            <c:idx val="8"/>
            <c:invertIfNegative val="0"/>
            <c:bubble3D val="0"/>
            <c:spPr>
              <a:solidFill>
                <a:srgbClr val="FF0000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B122-43AB-B0DE-4EF4CAAA176C}"/>
              </c:ext>
            </c:extLst>
          </c:dPt>
          <c:dPt>
            <c:idx val="9"/>
            <c:invertIfNegative val="0"/>
            <c:bubble3D val="0"/>
            <c:spPr>
              <a:solidFill>
                <a:srgbClr val="FF0000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B122-43AB-B0DE-4EF4CAAA176C}"/>
              </c:ext>
            </c:extLst>
          </c:dPt>
          <c:dPt>
            <c:idx val="11"/>
            <c:invertIfNegative val="0"/>
            <c:bubble3D val="0"/>
            <c:spPr>
              <a:solidFill>
                <a:srgbClr val="4472C4">
                  <a:lumMod val="40000"/>
                  <a:lumOff val="60000"/>
                </a:srgb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B122-43AB-B0DE-4EF4CAAA176C}"/>
              </c:ext>
            </c:extLst>
          </c:dPt>
          <c:dPt>
            <c:idx val="12"/>
            <c:invertIfNegative val="0"/>
            <c:bubble3D val="0"/>
            <c:spPr>
              <a:solidFill>
                <a:srgbClr val="4472C4">
                  <a:lumMod val="40000"/>
                  <a:lumOff val="60000"/>
                </a:srgb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B122-43AB-B0DE-4EF4CAAA176C}"/>
              </c:ext>
            </c:extLst>
          </c:dPt>
          <c:dPt>
            <c:idx val="13"/>
            <c:invertIfNegative val="0"/>
            <c:bubble3D val="0"/>
            <c:spPr>
              <a:solidFill>
                <a:srgbClr val="4472C4">
                  <a:lumMod val="40000"/>
                  <a:lumOff val="60000"/>
                </a:srgb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B122-43AB-B0DE-4EF4CAAA176C}"/>
              </c:ext>
            </c:extLst>
          </c:dPt>
          <c:dPt>
            <c:idx val="14"/>
            <c:invertIfNegative val="0"/>
            <c:bubble3D val="0"/>
            <c:spPr>
              <a:solidFill>
                <a:srgbClr val="4472C4">
                  <a:lumMod val="40000"/>
                  <a:lumOff val="60000"/>
                </a:srgb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B122-43AB-B0DE-4EF4CAAA176C}"/>
              </c:ext>
            </c:extLst>
          </c:dPt>
          <c:dPt>
            <c:idx val="15"/>
            <c:invertIfNegative val="0"/>
            <c:bubble3D val="0"/>
            <c:spPr>
              <a:solidFill>
                <a:srgbClr val="4472C4">
                  <a:lumMod val="40000"/>
                  <a:lumOff val="60000"/>
                </a:srgb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B122-43AB-B0DE-4EF4CAAA176C}"/>
              </c:ext>
            </c:extLst>
          </c:dPt>
          <c:dPt>
            <c:idx val="17"/>
            <c:invertIfNegative val="0"/>
            <c:bubble3D val="0"/>
            <c:spPr>
              <a:solidFill>
                <a:srgbClr val="FFC000">
                  <a:lumMod val="40000"/>
                  <a:lumOff val="60000"/>
                </a:srgb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B122-43AB-B0DE-4EF4CAAA176C}"/>
              </c:ext>
            </c:extLst>
          </c:dPt>
          <c:dPt>
            <c:idx val="18"/>
            <c:invertIfNegative val="0"/>
            <c:bubble3D val="0"/>
            <c:spPr>
              <a:solidFill>
                <a:srgbClr val="FFC000">
                  <a:lumMod val="40000"/>
                  <a:lumOff val="60000"/>
                </a:srgb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D-B122-43AB-B0DE-4EF4CAAA176C}"/>
              </c:ext>
            </c:extLst>
          </c:dPt>
          <c:dPt>
            <c:idx val="19"/>
            <c:invertIfNegative val="0"/>
            <c:bubble3D val="0"/>
            <c:spPr>
              <a:solidFill>
                <a:srgbClr val="FFC000">
                  <a:lumMod val="40000"/>
                  <a:lumOff val="60000"/>
                </a:srgb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F-B122-43AB-B0DE-4EF4CAAA176C}"/>
              </c:ext>
            </c:extLst>
          </c:dPt>
          <c:dPt>
            <c:idx val="20"/>
            <c:invertIfNegative val="0"/>
            <c:bubble3D val="0"/>
            <c:spPr>
              <a:solidFill>
                <a:srgbClr val="FFC000">
                  <a:lumMod val="40000"/>
                  <a:lumOff val="60000"/>
                </a:srgb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1-B122-43AB-B0DE-4EF4CAAA176C}"/>
              </c:ext>
            </c:extLst>
          </c:dPt>
          <c:dPt>
            <c:idx val="21"/>
            <c:invertIfNegative val="0"/>
            <c:bubble3D val="0"/>
            <c:spPr>
              <a:solidFill>
                <a:srgbClr val="FFC000">
                  <a:lumMod val="40000"/>
                  <a:lumOff val="60000"/>
                </a:srgb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3-B122-43AB-B0DE-4EF4CAAA176C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N$3:$N$24</c:f>
                <c:numCache>
                  <c:formatCode>General</c:formatCode>
                  <c:ptCount val="22"/>
                  <c:pt idx="0">
                    <c:v>0.56199492411723395</c:v>
                  </c:pt>
                  <c:pt idx="2">
                    <c:v>0.53220162379984037</c:v>
                  </c:pt>
                  <c:pt idx="3">
                    <c:v>0.50756950422059299</c:v>
                  </c:pt>
                  <c:pt idx="5">
                    <c:v>0.53690856659561659</c:v>
                  </c:pt>
                  <c:pt idx="6">
                    <c:v>0.44752931330826778</c:v>
                  </c:pt>
                  <c:pt idx="7">
                    <c:v>0.48034116314051517</c:v>
                  </c:pt>
                  <c:pt idx="8">
                    <c:v>0.47471022480129976</c:v>
                  </c:pt>
                  <c:pt idx="9">
                    <c:v>0.47413988489229991</c:v>
                  </c:pt>
                  <c:pt idx="11">
                    <c:v>0.46511128907923299</c:v>
                  </c:pt>
                  <c:pt idx="12">
                    <c:v>0.4977533486338741</c:v>
                  </c:pt>
                  <c:pt idx="13">
                    <c:v>0.46230689082953785</c:v>
                  </c:pt>
                  <c:pt idx="14">
                    <c:v>0.43041233310816607</c:v>
                  </c:pt>
                  <c:pt idx="15">
                    <c:v>0.43937030655911219</c:v>
                  </c:pt>
                  <c:pt idx="17">
                    <c:v>0.41255646403535273</c:v>
                  </c:pt>
                  <c:pt idx="18">
                    <c:v>0.38582672609092195</c:v>
                  </c:pt>
                  <c:pt idx="19">
                    <c:v>0.55224327994198563</c:v>
                  </c:pt>
                  <c:pt idx="20">
                    <c:v>0.37342190931405095</c:v>
                  </c:pt>
                  <c:pt idx="21">
                    <c:v>0.41133343592473787</c:v>
                  </c:pt>
                </c:numCache>
              </c:numRef>
            </c:plus>
            <c:minus>
              <c:numRef>
                <c:f>Sheet1!$N$3:$N$24</c:f>
                <c:numCache>
                  <c:formatCode>General</c:formatCode>
                  <c:ptCount val="22"/>
                  <c:pt idx="0">
                    <c:v>0.56199492411723395</c:v>
                  </c:pt>
                  <c:pt idx="2">
                    <c:v>0.53220162379984037</c:v>
                  </c:pt>
                  <c:pt idx="3">
                    <c:v>0.50756950422059299</c:v>
                  </c:pt>
                  <c:pt idx="5">
                    <c:v>0.53690856659561659</c:v>
                  </c:pt>
                  <c:pt idx="6">
                    <c:v>0.44752931330826778</c:v>
                  </c:pt>
                  <c:pt idx="7">
                    <c:v>0.48034116314051517</c:v>
                  </c:pt>
                  <c:pt idx="8">
                    <c:v>0.47471022480129976</c:v>
                  </c:pt>
                  <c:pt idx="9">
                    <c:v>0.47413988489229991</c:v>
                  </c:pt>
                  <c:pt idx="11">
                    <c:v>0.46511128907923299</c:v>
                  </c:pt>
                  <c:pt idx="12">
                    <c:v>0.4977533486338741</c:v>
                  </c:pt>
                  <c:pt idx="13">
                    <c:v>0.46230689082953785</c:v>
                  </c:pt>
                  <c:pt idx="14">
                    <c:v>0.43041233310816607</c:v>
                  </c:pt>
                  <c:pt idx="15">
                    <c:v>0.43937030655911219</c:v>
                  </c:pt>
                  <c:pt idx="17">
                    <c:v>0.41255646403535273</c:v>
                  </c:pt>
                  <c:pt idx="18">
                    <c:v>0.38582672609092195</c:v>
                  </c:pt>
                  <c:pt idx="19">
                    <c:v>0.55224327994198563</c:v>
                  </c:pt>
                  <c:pt idx="20">
                    <c:v>0.37342190931405095</c:v>
                  </c:pt>
                  <c:pt idx="21">
                    <c:v>0.41133343592473787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Sheet1!$G$3:$G$24</c:f>
              <c:strCache>
                <c:ptCount val="22"/>
                <c:pt idx="0">
                  <c:v>Untreated</c:v>
                </c:pt>
                <c:pt idx="2">
                  <c:v>BTZ 5nM</c:v>
                </c:pt>
                <c:pt idx="3">
                  <c:v>BTZ 10nM</c:v>
                </c:pt>
                <c:pt idx="5">
                  <c:v>Tub-A</c:v>
                </c:pt>
                <c:pt idx="6">
                  <c:v>WT-161</c:v>
                </c:pt>
                <c:pt idx="7">
                  <c:v>ACY-1215</c:v>
                </c:pt>
                <c:pt idx="8">
                  <c:v>ACY-738</c:v>
                </c:pt>
                <c:pt idx="9">
                  <c:v>ACY-241</c:v>
                </c:pt>
                <c:pt idx="11">
                  <c:v>Tub-A</c:v>
                </c:pt>
                <c:pt idx="12">
                  <c:v>WT-161</c:v>
                </c:pt>
                <c:pt idx="13">
                  <c:v>ACY-1215</c:v>
                </c:pt>
                <c:pt idx="14">
                  <c:v>ACY-738</c:v>
                </c:pt>
                <c:pt idx="15">
                  <c:v>ACY-241</c:v>
                </c:pt>
                <c:pt idx="17">
                  <c:v>Tub-A</c:v>
                </c:pt>
                <c:pt idx="18">
                  <c:v>WT-161</c:v>
                </c:pt>
                <c:pt idx="19">
                  <c:v>ACY-1215</c:v>
                </c:pt>
                <c:pt idx="20">
                  <c:v>ACY-738</c:v>
                </c:pt>
                <c:pt idx="21">
                  <c:v>ACY-241</c:v>
                </c:pt>
              </c:strCache>
            </c:strRef>
          </c:cat>
          <c:val>
            <c:numRef>
              <c:f>Sheet1!$K$3:$K$24</c:f>
              <c:numCache>
                <c:formatCode>General</c:formatCode>
                <c:ptCount val="22"/>
                <c:pt idx="0">
                  <c:v>100</c:v>
                </c:pt>
                <c:pt idx="2">
                  <c:v>119.45392491467577</c:v>
                </c:pt>
                <c:pt idx="3">
                  <c:v>169.02730375426623</c:v>
                </c:pt>
                <c:pt idx="5">
                  <c:v>82.295221843003404</c:v>
                </c:pt>
                <c:pt idx="6">
                  <c:v>83.404436860068259</c:v>
                </c:pt>
                <c:pt idx="7">
                  <c:v>89.50511945392492</c:v>
                </c:pt>
                <c:pt idx="8">
                  <c:v>98.293515358361773</c:v>
                </c:pt>
                <c:pt idx="9">
                  <c:v>93.771331058020479</c:v>
                </c:pt>
                <c:pt idx="11">
                  <c:v>96.629692832764505</c:v>
                </c:pt>
                <c:pt idx="12">
                  <c:v>117.7901023890785</c:v>
                </c:pt>
                <c:pt idx="13">
                  <c:v>95.392491467576789</c:v>
                </c:pt>
                <c:pt idx="14">
                  <c:v>98.890784982935159</c:v>
                </c:pt>
                <c:pt idx="15">
                  <c:v>98.933447098976117</c:v>
                </c:pt>
                <c:pt idx="17">
                  <c:v>107.16723549488054</c:v>
                </c:pt>
                <c:pt idx="18">
                  <c:v>98.464163822525592</c:v>
                </c:pt>
                <c:pt idx="19">
                  <c:v>102.13310580204778</c:v>
                </c:pt>
                <c:pt idx="20">
                  <c:v>103.28498293515358</c:v>
                </c:pt>
                <c:pt idx="21">
                  <c:v>116.4249146757679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4-B122-43AB-B0DE-4EF4CAAA176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"/>
        <c:axId val="607278200"/>
        <c:axId val="1131435656"/>
      </c:barChart>
      <c:catAx>
        <c:axId val="607278200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3360000" spcFirstLastPara="1" vertOverflow="ellipsis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31435656"/>
        <c:crosses val="autoZero"/>
        <c:auto val="1"/>
        <c:lblAlgn val="ctr"/>
        <c:lblOffset val="100"/>
        <c:tickMarkSkip val="1"/>
        <c:noMultiLvlLbl val="0"/>
      </c:catAx>
      <c:valAx>
        <c:axId val="1131435656"/>
        <c:scaling>
          <c:orientation val="minMax"/>
          <c:max val="17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07278200"/>
        <c:crosses val="autoZero"/>
        <c:crossBetween val="between"/>
        <c:majorUnit val="2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67D377B7-C823-472C-9E09-6D86554DC02C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24F9BC96-858B-41C2-877C-3E56BFBCC5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77778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20730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48891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96872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2090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4784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51218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6452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70106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40298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56530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60492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68365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1DF55FD1-50E3-414B-C3F5-C0024BBB3CF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70131705"/>
              </p:ext>
            </p:extLst>
          </p:nvPr>
        </p:nvGraphicFramePr>
        <p:xfrm>
          <a:off x="527583" y="3245585"/>
          <a:ext cx="7666944" cy="38948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3" name="Chart 12">
            <a:extLst>
              <a:ext uri="{FF2B5EF4-FFF2-40B4-BE49-F238E27FC236}">
                <a16:creationId xmlns:a16="http://schemas.microsoft.com/office/drawing/2014/main" id="{D1F4A3BD-ACAA-41FF-8C30-63A5451D9FE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39563256"/>
              </p:ext>
            </p:extLst>
          </p:nvPr>
        </p:nvGraphicFramePr>
        <p:xfrm>
          <a:off x="551867" y="172693"/>
          <a:ext cx="7744266" cy="33265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Rectangle 4"/>
          <p:cNvSpPr/>
          <p:nvPr/>
        </p:nvSpPr>
        <p:spPr>
          <a:xfrm rot="16200000">
            <a:off x="-190781" y="1366107"/>
            <a:ext cx="226536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b="1"/>
              <a:t>Aggresomes, Relative %</a:t>
            </a: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02027437-1B62-84AC-A208-250B21899565}"/>
              </a:ext>
            </a:extLst>
          </p:cNvPr>
          <p:cNvCxnSpPr>
            <a:cxnSpLocks/>
          </p:cNvCxnSpPr>
          <p:nvPr/>
        </p:nvCxnSpPr>
        <p:spPr>
          <a:xfrm>
            <a:off x="1396446" y="4290872"/>
            <a:ext cx="6763110" cy="0"/>
          </a:xfrm>
          <a:prstGeom prst="line">
            <a:avLst/>
          </a:prstGeom>
          <a:ln w="12700"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02027437-1B62-84AC-A208-250B21899565}"/>
              </a:ext>
            </a:extLst>
          </p:cNvPr>
          <p:cNvCxnSpPr>
            <a:cxnSpLocks/>
          </p:cNvCxnSpPr>
          <p:nvPr/>
        </p:nvCxnSpPr>
        <p:spPr>
          <a:xfrm flipV="1">
            <a:off x="1396446" y="1255485"/>
            <a:ext cx="6822111" cy="13063"/>
          </a:xfrm>
          <a:prstGeom prst="line">
            <a:avLst/>
          </a:prstGeom>
          <a:ln w="12700"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F23616FA-F8FD-38C4-3E28-CE7A311247D2}"/>
              </a:ext>
            </a:extLst>
          </p:cNvPr>
          <p:cNvSpPr txBox="1"/>
          <p:nvPr/>
        </p:nvSpPr>
        <p:spPr>
          <a:xfrm>
            <a:off x="1532154" y="3239618"/>
            <a:ext cx="69228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     BTZ alone                   HDAC6i alone                           HDAC6i + BTZ  (5nM)                HDAC6i + BTZ  (10nM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F23616FA-F8FD-38C4-3E28-CE7A311247D2}"/>
              </a:ext>
            </a:extLst>
          </p:cNvPr>
          <p:cNvSpPr txBox="1"/>
          <p:nvPr/>
        </p:nvSpPr>
        <p:spPr>
          <a:xfrm>
            <a:off x="1396446" y="6552764"/>
            <a:ext cx="69228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     BTZ alone                   HDAC6i alone                           HDAC6i + BTZ  (5nM)                HDAC6i + BTZ  (10nM)</a:t>
            </a:r>
          </a:p>
        </p:txBody>
      </p:sp>
      <p:sp>
        <p:nvSpPr>
          <p:cNvPr id="25" name="Rectangle 24"/>
          <p:cNvSpPr/>
          <p:nvPr/>
        </p:nvSpPr>
        <p:spPr>
          <a:xfrm>
            <a:off x="214677" y="356776"/>
            <a:ext cx="31290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/>
          </a:p>
        </p:txBody>
      </p:sp>
      <p:sp>
        <p:nvSpPr>
          <p:cNvPr id="26" name="Rectangle 25"/>
          <p:cNvSpPr/>
          <p:nvPr/>
        </p:nvSpPr>
        <p:spPr>
          <a:xfrm>
            <a:off x="246763" y="3314551"/>
            <a:ext cx="32573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41713" y="18222"/>
            <a:ext cx="971741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Fig. S15</a:t>
            </a:r>
            <a:endParaRPr lang="en-US" sz="1600"/>
          </a:p>
        </p:txBody>
      </p:sp>
      <p:sp>
        <p:nvSpPr>
          <p:cNvPr id="2" name="Rectangle 1"/>
          <p:cNvSpPr/>
          <p:nvPr/>
        </p:nvSpPr>
        <p:spPr>
          <a:xfrm>
            <a:off x="8335873" y="387312"/>
            <a:ext cx="3659393" cy="526297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ea typeface="Times New Roman" panose="02020603050405020304" pitchFamily="18" charset="0"/>
              </a:rPr>
              <a:t>Fig. S15. 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Effect of HDAC6 inhibitors on </a:t>
            </a:r>
            <a:r>
              <a:rPr lang="en-US" sz="1200" b="1">
                <a:solidFill>
                  <a:srgbClr val="C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.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aggresome formation and </a:t>
            </a:r>
            <a:r>
              <a:rPr lang="en-US" sz="1200" b="1">
                <a:solidFill>
                  <a:srgbClr val="C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b.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autophagosome formation. RPMI8226 cells were treated with bortezomib and HDAC6 at the indicated concentrations for 16 h. Aggresomes were quantitated by flow cytometry using the cell-based Proteostat</a:t>
            </a:r>
            <a:r>
              <a:rPr lang="en-US" sz="1200" baseline="300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®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aggresome detection kit (Enzo Life Sciences, Farmingdale, NY). The kit utilizes a molecular rotor dye which while in solution is prevented from fluorescing by free intramolecular rotation along a single central bond. Specifically intercalation of the dye into the cross-</a:t>
            </a:r>
            <a:r>
              <a:rPr lang="en-US" sz="1200">
                <a:solidFill>
                  <a:srgbClr val="000000"/>
                </a:solidFill>
                <a:latin typeface="Symbol" panose="05050102010706020507" pitchFamily="18" charset="2"/>
                <a:ea typeface="Times New Roman" panose="02020603050405020304" pitchFamily="18" charset="0"/>
              </a:rPr>
              <a:t>b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spine of quaternary protein structures typically found in misfolded and aggregated proteins, inhibits the dye’s rotation and leads to a strong fluorescence. </a:t>
            </a:r>
            <a:r>
              <a:rPr lang="en-US" sz="1200" b="1">
                <a:solidFill>
                  <a:srgbClr val="C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b. 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utophagosome formation. RPMI8226 cells were treated with bortezomib and HDAC6 at the indicated concentrations for 16 h. Autophagosomes were quantitated by flow cytometry using the Cyto-ID autophagosome detection kit which measures autophagic vacuoles and monitors autophagic flux in lysosomally inhibited live cells using a novel dye that selectively labels accumulated autophagic vacuoles (Enzo Life Sciences). The 488nm-excitable green dye allows for minimal staining of lysosomes while exhibiting bright fluorescence upon incorporation 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into </a:t>
            </a:r>
            <a:r>
              <a:rPr lang="en-US" sz="120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preautophagosomes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, autophagosomes, 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nd </a:t>
            </a:r>
            <a:r>
              <a:rPr lang="en-US" sz="120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utolysosomes. 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ll assays were performed in triplicate. Error bars represent the SD of the mean.</a:t>
            </a:r>
            <a:endParaRPr lang="en-US" sz="120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856733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6383</TotalTime>
  <Words>263</Words>
  <Application>Microsoft Office PowerPoint</Application>
  <PresentationFormat>Widescreen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imes New Roman</vt:lpstr>
      <vt:lpstr>Office Theme</vt:lpstr>
      <vt:lpstr>PowerPoint Presentation</vt:lpstr>
    </vt:vector>
  </TitlesOfParts>
  <Company>UHH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iscoll, James Joseph</dc:creator>
  <cp:lastModifiedBy>Driscoll, James Joseph</cp:lastModifiedBy>
  <cp:revision>99</cp:revision>
  <cp:lastPrinted>2024-03-02T18:31:01Z</cp:lastPrinted>
  <dcterms:created xsi:type="dcterms:W3CDTF">2022-08-15T18:48:13Z</dcterms:created>
  <dcterms:modified xsi:type="dcterms:W3CDTF">2024-05-03T22:21:50Z</dcterms:modified>
</cp:coreProperties>
</file>